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9" r:id="rId2"/>
  </p:sldIdLst>
  <p:sldSz cx="9906000" cy="6858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uthor" initials="A" lastIdx="1" clrIdx="0">
    <p:extLst>
      <p:ext uri="{19B8F6BF-5375-455C-9EA6-DF929625EA0E}">
        <p15:presenceInfo xmlns:p15="http://schemas.microsoft.com/office/powerpoint/2012/main" userId="Autho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412"/>
    <p:restoredTop sz="94574"/>
  </p:normalViewPr>
  <p:slideViewPr>
    <p:cSldViewPr snapToGrid="0" snapToObjects="1" showGuides="1">
      <p:cViewPr>
        <p:scale>
          <a:sx n="118" d="100"/>
          <a:sy n="118" d="100"/>
        </p:scale>
        <p:origin x="584" y="136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9EBFB23-8B90-1C4C-83A6-A560B664F6BD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D744DF7-7E64-6D46-9343-46E4DBCD06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56251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1200150" y="1143000"/>
            <a:ext cx="4457700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D744DF7-7E64-6D46-9343-46E4DBCD06E6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70587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57804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65896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92996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15494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60679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92014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39653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85929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14670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16696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97707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13693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471D9888-CC33-644F-8FED-2A74310EED60}"/>
              </a:ext>
            </a:extLst>
          </p:cNvPr>
          <p:cNvSpPr/>
          <p:nvPr/>
        </p:nvSpPr>
        <p:spPr>
          <a:xfrm>
            <a:off x="546411" y="1370593"/>
            <a:ext cx="31290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dirty="0"/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12239042-7868-AB42-A5BF-DBBBFA527A23}"/>
              </a:ext>
            </a:extLst>
          </p:cNvPr>
          <p:cNvSpPr/>
          <p:nvPr/>
        </p:nvSpPr>
        <p:spPr>
          <a:xfrm>
            <a:off x="5085482" y="1370593"/>
            <a:ext cx="32573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ja-JP" altLang="en-US" dirty="0"/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id="{BA148AAA-A0C4-884D-8B73-ED97549FB438}"/>
              </a:ext>
            </a:extLst>
          </p:cNvPr>
          <p:cNvPicPr/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853"/>
          <a:stretch/>
        </p:blipFill>
        <p:spPr bwMode="auto">
          <a:xfrm>
            <a:off x="5085483" y="1670675"/>
            <a:ext cx="4378422" cy="3352130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85B727FD-1C39-9343-816D-59BFF08A8981}"/>
              </a:ext>
            </a:extLst>
          </p:cNvPr>
          <p:cNvSpPr txBox="1"/>
          <p:nvPr/>
        </p:nvSpPr>
        <p:spPr>
          <a:xfrm>
            <a:off x="897789" y="5518931"/>
            <a:ext cx="8254214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4: Figure </a:t>
            </a:r>
            <a:r>
              <a:rPr lang="en-US" altLang="ja-JP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. Forest plot of OS (a) and PFS (b) with doxorubicin alone vs experimental chemotherapy.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Abbreviations: CI, confidence interval; IV, inverse variance; OS, overall survival; PFS, progression-free survival; SE, standard error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図 7">
            <a:extLst>
              <a:ext uri="{FF2B5EF4-FFF2-40B4-BE49-F238E27FC236}">
                <a16:creationId xmlns:a16="http://schemas.microsoft.com/office/drawing/2014/main" id="{DEA4D23C-26DF-1847-890A-546765422476}"/>
              </a:ext>
            </a:extLst>
          </p:cNvPr>
          <p:cNvPicPr/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9198"/>
          <a:stretch/>
        </p:blipFill>
        <p:spPr bwMode="auto">
          <a:xfrm>
            <a:off x="546410" y="1670675"/>
            <a:ext cx="4381200" cy="3418643"/>
          </a:xfrm>
          <a:prstGeom prst="rect">
            <a:avLst/>
          </a:prstGeom>
          <a:solidFill>
            <a:schemeClr val="bg1"/>
          </a:solidFill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7295492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</TotalTime>
  <Words>55</Words>
  <Application>Microsoft Macintosh PowerPoint</Application>
  <PresentationFormat>A4 210 x 297 mm</PresentationFormat>
  <Paragraphs>5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/>
  <cp:lastModifiedBy>田仲和宏</cp:lastModifiedBy>
  <cp:revision>39</cp:revision>
  <cp:lastPrinted>2018-06-08T06:33:36Z</cp:lastPrinted>
  <dcterms:created xsi:type="dcterms:W3CDTF">2018-05-19T00:24:53Z</dcterms:created>
  <dcterms:modified xsi:type="dcterms:W3CDTF">2018-12-11T05:03:38Z</dcterms:modified>
</cp:coreProperties>
</file>